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06" autoAdjust="0"/>
    <p:restoredTop sz="94609" autoAdjust="0"/>
  </p:normalViewPr>
  <p:slideViewPr>
    <p:cSldViewPr snapToGrid="0">
      <p:cViewPr varScale="1">
        <p:scale>
          <a:sx n="120" d="100"/>
          <a:sy n="120" d="100"/>
        </p:scale>
        <p:origin x="1026" y="96"/>
      </p:cViewPr>
      <p:guideLst>
        <p:guide/>
        <p:guide orient="horz"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275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358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7416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4359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96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342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6524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5512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8357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0096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393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82EDD-51E5-497C-885A-24B00E5043E7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69AE8-DFBF-49D0-9253-144DF594EC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669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343166" y="5967472"/>
            <a:ext cx="6732933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tere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onatal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matoxylin-eosin-stained lung sections of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ND60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c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ated with different concentrations of oxygen unti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ND14.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ree examples each treatment are shown as black-white conversion.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848478" y="4621408"/>
            <a:ext cx="1225015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 defTabSz="536575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ve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644404" y="2953140"/>
            <a:ext cx="1629993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 defTabSz="536575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derate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958918" y="1223513"/>
            <a:ext cx="98235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 defTabSz="536575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44"/>
          <p:cNvCxnSpPr/>
          <p:nvPr/>
        </p:nvCxnSpPr>
        <p:spPr>
          <a:xfrm rot="5400000">
            <a:off x="8136489" y="5222687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 rot="16200000">
            <a:off x="8186268" y="5114965"/>
            <a:ext cx="5309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  <a:endParaRPr lang="en-GB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809" y="3955667"/>
            <a:ext cx="2115495" cy="1582049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195" y="3953495"/>
            <a:ext cx="2115495" cy="158204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423" y="3945423"/>
            <a:ext cx="2115495" cy="158204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8" cstate="print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195" y="559687"/>
            <a:ext cx="2115495" cy="1582049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10" cstate="print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423" y="2252555"/>
            <a:ext cx="2115495" cy="1582049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12" cstate="print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809" y="2252555"/>
            <a:ext cx="2115495" cy="1582049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>
          <a:blip r:embed="rId14" cstate="print">
            <a:grayscl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203" y="2252555"/>
            <a:ext cx="2115495" cy="1582049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>
          <a:blip r:embed="rId16" cstate="print">
            <a:grayscl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423" y="559687"/>
            <a:ext cx="2115495" cy="1582049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18" cstate="print">
            <a:grayscl/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813" y="559687"/>
            <a:ext cx="2115495" cy="1582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8266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</Words>
  <Application>Microsoft Office PowerPoint</Application>
  <PresentationFormat>A4-Papier (210 x 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Halle (Saale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artling, Babett</dc:creator>
  <cp:lastModifiedBy>Bartling, Babett</cp:lastModifiedBy>
  <cp:revision>15</cp:revision>
  <dcterms:created xsi:type="dcterms:W3CDTF">2019-09-17T05:28:16Z</dcterms:created>
  <dcterms:modified xsi:type="dcterms:W3CDTF">2019-09-17T09:41:40Z</dcterms:modified>
</cp:coreProperties>
</file>